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 varScale="1">
        <p:scale>
          <a:sx n="56" d="100"/>
          <a:sy n="56" d="100"/>
        </p:scale>
        <p:origin x="-2400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6Jun20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8Apr20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6541553731128"/>
          <c:y val="0.0626724346058128"/>
          <c:w val="0.769976168964659"/>
          <c:h val="0.705907987300006"/>
        </c:manualLayout>
      </c:layout>
      <c:barChart>
        <c:barDir val="col"/>
        <c:grouping val="clustered"/>
        <c:varyColors val="0"/>
        <c:ser>
          <c:idx val="0"/>
          <c:order val="0"/>
          <c:tx>
            <c:v>LI</c:v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AM_26Jun15!$E$12:$E$19</c:f>
                <c:numCache>
                  <c:formatCode>General</c:formatCode>
                  <c:ptCount val="8"/>
                  <c:pt idx="0">
                    <c:v>0.0615993988290675</c:v>
                  </c:pt>
                  <c:pt idx="1">
                    <c:v>0.0652383093483723</c:v>
                  </c:pt>
                  <c:pt idx="2">
                    <c:v>0.058717134089699</c:v>
                  </c:pt>
                  <c:pt idx="3">
                    <c:v>0.0579090323791653</c:v>
                  </c:pt>
                  <c:pt idx="4">
                    <c:v>0.0788459904093931</c:v>
                  </c:pt>
                  <c:pt idx="5">
                    <c:v>0.0823551159484344</c:v>
                  </c:pt>
                  <c:pt idx="6">
                    <c:v>0.0639317279923776</c:v>
                  </c:pt>
                  <c:pt idx="7">
                    <c:v>0.06110888818453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PAM_26Jun15!$A$12:$A$19</c:f>
              <c:strCache>
                <c:ptCount val="8"/>
                <c:pt idx="0">
                  <c:v>MB047B</c:v>
                </c:pt>
                <c:pt idx="1">
                  <c:v>MB316B</c:v>
                </c:pt>
                <c:pt idx="2">
                  <c:v>MB109B</c:v>
                </c:pt>
                <c:pt idx="3">
                  <c:v>MB194B</c:v>
                </c:pt>
                <c:pt idx="4">
                  <c:v>MB213B</c:v>
                </c:pt>
                <c:pt idx="5">
                  <c:v>MB087C</c:v>
                </c:pt>
                <c:pt idx="6">
                  <c:v>MB025B</c:v>
                </c:pt>
                <c:pt idx="7">
                  <c:v>MB301B</c:v>
                </c:pt>
              </c:strCache>
            </c:strRef>
          </c:cat>
          <c:val>
            <c:numRef>
              <c:f>PAM_26Jun15!$B$12:$B$19</c:f>
              <c:numCache>
                <c:formatCode>General</c:formatCode>
                <c:ptCount val="8"/>
                <c:pt idx="0">
                  <c:v>0.065386231884058</c:v>
                </c:pt>
                <c:pt idx="1">
                  <c:v>0.101137101449275</c:v>
                </c:pt>
                <c:pt idx="2">
                  <c:v>0.219717361111111</c:v>
                </c:pt>
                <c:pt idx="3">
                  <c:v>0.306186060606061</c:v>
                </c:pt>
                <c:pt idx="4">
                  <c:v>0.198494393939394</c:v>
                </c:pt>
                <c:pt idx="5">
                  <c:v>0.236409111111111</c:v>
                </c:pt>
                <c:pt idx="6">
                  <c:v>0.344270138888889</c:v>
                </c:pt>
                <c:pt idx="7">
                  <c:v>0.178031875</c:v>
                </c:pt>
              </c:numCache>
            </c:numRef>
          </c:val>
        </c:ser>
        <c:ser>
          <c:idx val="1"/>
          <c:order val="1"/>
          <c:tx>
            <c:v>MI</c:v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PAM_26Jun15!$F$12:$F$19</c:f>
                <c:numCache>
                  <c:formatCode>General</c:formatCode>
                  <c:ptCount val="8"/>
                  <c:pt idx="0">
                    <c:v>0.0788139062836091</c:v>
                  </c:pt>
                  <c:pt idx="1">
                    <c:v>0.108156909645906</c:v>
                  </c:pt>
                  <c:pt idx="2">
                    <c:v>0.0592891759811152</c:v>
                  </c:pt>
                  <c:pt idx="3">
                    <c:v>0.0684676882169693</c:v>
                  </c:pt>
                  <c:pt idx="4">
                    <c:v>0.0865995942848213</c:v>
                  </c:pt>
                  <c:pt idx="5">
                    <c:v>0.108242044238101</c:v>
                  </c:pt>
                  <c:pt idx="6">
                    <c:v>0.0529055112087886</c:v>
                  </c:pt>
                  <c:pt idx="7">
                    <c:v>0.077294990332622</c:v>
                  </c:pt>
                </c:numCache>
              </c:numRef>
            </c:minus>
          </c:errBars>
          <c:cat>
            <c:strRef>
              <c:f>PAM_26Jun15!$A$12:$A$19</c:f>
              <c:strCache>
                <c:ptCount val="8"/>
                <c:pt idx="0">
                  <c:v>MB047B</c:v>
                </c:pt>
                <c:pt idx="1">
                  <c:v>MB316B</c:v>
                </c:pt>
                <c:pt idx="2">
                  <c:v>MB109B</c:v>
                </c:pt>
                <c:pt idx="3">
                  <c:v>MB194B</c:v>
                </c:pt>
                <c:pt idx="4">
                  <c:v>MB213B</c:v>
                </c:pt>
                <c:pt idx="5">
                  <c:v>MB087C</c:v>
                </c:pt>
                <c:pt idx="6">
                  <c:v>MB025B</c:v>
                </c:pt>
                <c:pt idx="7">
                  <c:v>MB301B</c:v>
                </c:pt>
              </c:strCache>
            </c:strRef>
          </c:cat>
          <c:val>
            <c:numRef>
              <c:f>PAM_26Jun15!$C$12:$C$19</c:f>
              <c:numCache>
                <c:formatCode>General</c:formatCode>
                <c:ptCount val="8"/>
                <c:pt idx="0">
                  <c:v>-0.127468188405797</c:v>
                </c:pt>
                <c:pt idx="1">
                  <c:v>-0.283873768115942</c:v>
                </c:pt>
                <c:pt idx="2">
                  <c:v>-0.0216914583333333</c:v>
                </c:pt>
                <c:pt idx="3">
                  <c:v>-0.105551212121212</c:v>
                </c:pt>
                <c:pt idx="4">
                  <c:v>-0.124252196969697</c:v>
                </c:pt>
                <c:pt idx="5">
                  <c:v>-0.234056888888889</c:v>
                </c:pt>
                <c:pt idx="6">
                  <c:v>-0.0394618055555556</c:v>
                </c:pt>
                <c:pt idx="7">
                  <c:v>0.01912118055555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0583224"/>
        <c:axId val="-2100978248"/>
      </c:barChart>
      <c:catAx>
        <c:axId val="-2100583224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00978248"/>
        <c:crosses val="autoZero"/>
        <c:auto val="1"/>
        <c:lblAlgn val="ctr"/>
        <c:lblOffset val="100"/>
        <c:noMultiLvlLbl val="0"/>
      </c:catAx>
      <c:valAx>
        <c:axId val="-21009782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005832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14039687839625"/>
          <c:y val="0.060893235932297"/>
          <c:w val="0.124943695905514"/>
          <c:h val="0.19363770397960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7639176868589"/>
          <c:y val="0.0813013334699025"/>
          <c:w val="0.766399754955455"/>
          <c:h val="0.696104551679543"/>
        </c:manualLayout>
      </c:layout>
      <c:barChart>
        <c:barDir val="col"/>
        <c:grouping val="clustered"/>
        <c:varyColors val="0"/>
        <c:ser>
          <c:idx val="0"/>
          <c:order val="0"/>
          <c:tx>
            <c:v>LI</c:v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ortByPublishedOrder_12Jan!$S$61:$S$70</c:f>
                <c:numCache>
                  <c:formatCode>General</c:formatCode>
                  <c:ptCount val="10"/>
                  <c:pt idx="0">
                    <c:v>0.0639314798046547</c:v>
                  </c:pt>
                  <c:pt idx="1">
                    <c:v>0.0585793481256962</c:v>
                  </c:pt>
                  <c:pt idx="2">
                    <c:v>0.0524940467251733</c:v>
                  </c:pt>
                  <c:pt idx="3">
                    <c:v>0.0799916473539085</c:v>
                  </c:pt>
                  <c:pt idx="4">
                    <c:v>0.0552741739030777</c:v>
                  </c:pt>
                  <c:pt idx="5">
                    <c:v>0.0650682346917586</c:v>
                  </c:pt>
                  <c:pt idx="6">
                    <c:v>0.0680348637541041</c:v>
                  </c:pt>
                  <c:pt idx="7">
                    <c:v>0.059574619810805</c:v>
                  </c:pt>
                  <c:pt idx="8">
                    <c:v>0.0782686523145751</c:v>
                  </c:pt>
                  <c:pt idx="9">
                    <c:v>0.05279699372194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ortByPublishedOrder_12Jan!$O$61:$O$70</c:f>
              <c:strCache>
                <c:ptCount val="10"/>
                <c:pt idx="0">
                  <c:v>MB060B</c:v>
                </c:pt>
                <c:pt idx="1">
                  <c:v>MB065B</c:v>
                </c:pt>
                <c:pt idx="2">
                  <c:v>MB504B</c:v>
                </c:pt>
                <c:pt idx="3">
                  <c:v>MB438B</c:v>
                </c:pt>
                <c:pt idx="4">
                  <c:v>MB439B</c:v>
                </c:pt>
                <c:pt idx="5">
                  <c:v>MB502B</c:v>
                </c:pt>
                <c:pt idx="6">
                  <c:v>MB308B</c:v>
                </c:pt>
                <c:pt idx="7">
                  <c:v>MB058B</c:v>
                </c:pt>
                <c:pt idx="8">
                  <c:v>MB296B</c:v>
                </c:pt>
                <c:pt idx="9">
                  <c:v>MB304B</c:v>
                </c:pt>
              </c:strCache>
            </c:strRef>
          </c:cat>
          <c:val>
            <c:numRef>
              <c:f>SortByPublishedOrder_12Jan!$P$61:$P$70</c:f>
              <c:numCache>
                <c:formatCode>General</c:formatCode>
                <c:ptCount val="10"/>
                <c:pt idx="0">
                  <c:v>0.19740862745098</c:v>
                </c:pt>
                <c:pt idx="1">
                  <c:v>0.210003083333333</c:v>
                </c:pt>
                <c:pt idx="2">
                  <c:v>0.0926662121212121</c:v>
                </c:pt>
                <c:pt idx="3">
                  <c:v>0.0480218421052632</c:v>
                </c:pt>
                <c:pt idx="4">
                  <c:v>0.0618110317460317</c:v>
                </c:pt>
                <c:pt idx="5">
                  <c:v>0.220458333333333</c:v>
                </c:pt>
                <c:pt idx="6">
                  <c:v>0.310478260869565</c:v>
                </c:pt>
                <c:pt idx="7">
                  <c:v>0.294432391304348</c:v>
                </c:pt>
                <c:pt idx="8">
                  <c:v>0.333262619047619</c:v>
                </c:pt>
                <c:pt idx="9">
                  <c:v>0.193018636363636</c:v>
                </c:pt>
              </c:numCache>
            </c:numRef>
          </c:val>
        </c:ser>
        <c:ser>
          <c:idx val="1"/>
          <c:order val="1"/>
          <c:tx>
            <c:v>MI</c:v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SortByPublishedOrder_12Jan!$T$61:$T$70</c:f>
                <c:numCache>
                  <c:formatCode>General</c:formatCode>
                  <c:ptCount val="10"/>
                  <c:pt idx="0">
                    <c:v>0.0886206434643984</c:v>
                  </c:pt>
                  <c:pt idx="1">
                    <c:v>0.0896235667444837</c:v>
                  </c:pt>
                  <c:pt idx="2">
                    <c:v>0.0778778843361646</c:v>
                  </c:pt>
                  <c:pt idx="3">
                    <c:v>0.0841775634313049</c:v>
                  </c:pt>
                  <c:pt idx="4">
                    <c:v>0.0617402528930248</c:v>
                  </c:pt>
                  <c:pt idx="5">
                    <c:v>0.10087649228905</c:v>
                  </c:pt>
                  <c:pt idx="6">
                    <c:v>0.0741401291386284</c:v>
                  </c:pt>
                  <c:pt idx="7">
                    <c:v>0.0855058348539901</c:v>
                  </c:pt>
                  <c:pt idx="8">
                    <c:v>0.10152435755305</c:v>
                  </c:pt>
                  <c:pt idx="9">
                    <c:v>0.0658563617845832</c:v>
                  </c:pt>
                </c:numCache>
              </c:numRef>
            </c:minus>
          </c:errBars>
          <c:cat>
            <c:strRef>
              <c:f>SortByPublishedOrder_12Jan!$O$61:$O$70</c:f>
              <c:strCache>
                <c:ptCount val="10"/>
                <c:pt idx="0">
                  <c:v>MB060B</c:v>
                </c:pt>
                <c:pt idx="1">
                  <c:v>MB065B</c:v>
                </c:pt>
                <c:pt idx="2">
                  <c:v>MB504B</c:v>
                </c:pt>
                <c:pt idx="3">
                  <c:v>MB438B</c:v>
                </c:pt>
                <c:pt idx="4">
                  <c:v>MB439B</c:v>
                </c:pt>
                <c:pt idx="5">
                  <c:v>MB502B</c:v>
                </c:pt>
                <c:pt idx="6">
                  <c:v>MB308B</c:v>
                </c:pt>
                <c:pt idx="7">
                  <c:v>MB058B</c:v>
                </c:pt>
                <c:pt idx="8">
                  <c:v>MB296B</c:v>
                </c:pt>
                <c:pt idx="9">
                  <c:v>MB304B</c:v>
                </c:pt>
              </c:strCache>
            </c:strRef>
          </c:cat>
          <c:val>
            <c:numRef>
              <c:f>SortByPublishedOrder_12Jan!$Q$61:$Q$70</c:f>
              <c:numCache>
                <c:formatCode>General</c:formatCode>
                <c:ptCount val="10"/>
                <c:pt idx="0">
                  <c:v>-0.193963039215686</c:v>
                </c:pt>
                <c:pt idx="1">
                  <c:v>-0.209998</c:v>
                </c:pt>
                <c:pt idx="2">
                  <c:v>-0.259932121212121</c:v>
                </c:pt>
                <c:pt idx="3">
                  <c:v>-0.110648771929825</c:v>
                </c:pt>
                <c:pt idx="4">
                  <c:v>0.0985834126984127</c:v>
                </c:pt>
                <c:pt idx="5">
                  <c:v>-0.149090486111111</c:v>
                </c:pt>
                <c:pt idx="6">
                  <c:v>-0.19659847826087</c:v>
                </c:pt>
                <c:pt idx="7">
                  <c:v>-0.189520579710145</c:v>
                </c:pt>
                <c:pt idx="8">
                  <c:v>-0.223180396825397</c:v>
                </c:pt>
                <c:pt idx="9">
                  <c:v>-0.09517901515151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7751432"/>
        <c:axId val="-2115114360"/>
      </c:barChart>
      <c:catAx>
        <c:axId val="-2117751432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15114360"/>
        <c:crosses val="autoZero"/>
        <c:auto val="1"/>
        <c:lblAlgn val="ctr"/>
        <c:lblOffset val="100"/>
        <c:noMultiLvlLbl val="0"/>
      </c:catAx>
      <c:valAx>
        <c:axId val="-2115114360"/>
        <c:scaling>
          <c:orientation val="minMax"/>
          <c:min val="-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77514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16259561201611"/>
          <c:y val="0.0304350630836301"/>
          <c:w val="0.118331650925614"/>
          <c:h val="0.16363973906753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340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811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2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33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331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87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980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08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06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363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459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Chart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2526259"/>
              </p:ext>
            </p:extLst>
          </p:nvPr>
        </p:nvGraphicFramePr>
        <p:xfrm>
          <a:off x="384149" y="804673"/>
          <a:ext cx="3054840" cy="26343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68628" y="217859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igure S6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646855" y="629713"/>
            <a:ext cx="917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PAM Line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87895" y="3408724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γ4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2060" y="3794749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γ5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82583" y="4173598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β1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86946" y="4752448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β’1ap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9638" y="5119629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β’2a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9979" y="5688128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β’2p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84581" y="5306611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β2β’2a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79259" y="3601278"/>
            <a:ext cx="73230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>
                <a:latin typeface="Arial"/>
                <a:cs typeface="Arial"/>
              </a:rPr>
              <a:t>γ4&gt;</a:t>
            </a:r>
            <a:r>
              <a:rPr lang="en-US" sz="800" dirty="0" smtClean="0">
                <a:latin typeface="Arial"/>
                <a:cs typeface="Arial"/>
              </a:rPr>
              <a:t>γ1γ2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91606" y="3982667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α1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89052" y="4562633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β2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86492" y="4932967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β’1m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81755" y="5494585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β’2m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86032" y="4360131"/>
            <a:ext cx="52412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β1ped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221866" y="1464025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509356" y="1251372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104985" y="1249768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809776" y="1085640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395928" y="1173372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697497" y="1003838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990445" y="1325301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422093" y="544380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B</a:t>
            </a:r>
          </a:p>
        </p:txBody>
      </p:sp>
      <p:graphicFrame>
        <p:nvGraphicFramePr>
          <p:cNvPr id="28" name="Table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6532519"/>
              </p:ext>
            </p:extLst>
          </p:nvPr>
        </p:nvGraphicFramePr>
        <p:xfrm>
          <a:off x="4216278" y="3418334"/>
          <a:ext cx="2319450" cy="1112570"/>
        </p:xfrm>
        <a:graphic>
          <a:graphicData uri="http://schemas.openxmlformats.org/drawingml/2006/table">
            <a:tbl>
              <a:tblPr/>
              <a:tblGrid>
                <a:gridCol w="231945"/>
                <a:gridCol w="231945"/>
                <a:gridCol w="231945"/>
                <a:gridCol w="231945"/>
                <a:gridCol w="231945"/>
                <a:gridCol w="231945"/>
                <a:gridCol w="231945"/>
                <a:gridCol w="231945"/>
                <a:gridCol w="231945"/>
                <a:gridCol w="231945"/>
              </a:tblGrid>
              <a:tr h="222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2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2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2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2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30" name="Char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8686142"/>
              </p:ext>
            </p:extLst>
          </p:nvPr>
        </p:nvGraphicFramePr>
        <p:xfrm>
          <a:off x="3555083" y="866560"/>
          <a:ext cx="3030540" cy="26228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4173358" y="1373291"/>
            <a:ext cx="2428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381449" y="1354447"/>
            <a:ext cx="29958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639790" y="1577218"/>
            <a:ext cx="2428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304231" y="1321148"/>
            <a:ext cx="2997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546721" y="1150429"/>
            <a:ext cx="2894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776460" y="1198139"/>
            <a:ext cx="2875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994117" y="1091414"/>
            <a:ext cx="32155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267475" y="1392812"/>
            <a:ext cx="2428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707794" y="2581752"/>
            <a:ext cx="2428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582061" y="3432863"/>
            <a:ext cx="66072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γ1pedc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693341" y="3639644"/>
            <a:ext cx="54944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γ2α’1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693341" y="3869055"/>
            <a:ext cx="54944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α’2α2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693341" y="4100335"/>
            <a:ext cx="54944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α3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693341" y="4307951"/>
            <a:ext cx="54944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α’3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4681035" y="1076912"/>
            <a:ext cx="231552" cy="3454299"/>
          </a:xfrm>
          <a:prstGeom prst="rect">
            <a:avLst/>
          </a:prstGeom>
          <a:noFill/>
          <a:ln w="19050">
            <a:solidFill>
              <a:srgbClr val="95373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790018" y="629713"/>
            <a:ext cx="9717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PPL1 Line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17577" y="5443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A</a:t>
            </a:r>
            <a:endParaRPr lang="en-US" dirty="0">
              <a:latin typeface="Arial"/>
              <a:cs typeface="Arial"/>
            </a:endParaRPr>
          </a:p>
        </p:txBody>
      </p:sp>
      <p:graphicFrame>
        <p:nvGraphicFramePr>
          <p:cNvPr id="29" name="Table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3278939"/>
              </p:ext>
            </p:extLst>
          </p:nvPr>
        </p:nvGraphicFramePr>
        <p:xfrm>
          <a:off x="1010847" y="3418334"/>
          <a:ext cx="2304176" cy="2477046"/>
        </p:xfrm>
        <a:graphic>
          <a:graphicData uri="http://schemas.openxmlformats.org/drawingml/2006/table">
            <a:tbl>
              <a:tblPr/>
              <a:tblGrid>
                <a:gridCol w="288022"/>
                <a:gridCol w="288022"/>
                <a:gridCol w="288022"/>
                <a:gridCol w="288022"/>
                <a:gridCol w="288022"/>
                <a:gridCol w="288022"/>
                <a:gridCol w="288022"/>
                <a:gridCol w="288022"/>
              </a:tblGrid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7D7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7D7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F8F8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7D7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C2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9393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C5C5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EA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A1A1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B8B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C2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C2C2"/>
                    </a:solidFill>
                  </a:tcPr>
                </a:tc>
              </a:tr>
              <a:tr h="1905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B0B0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129251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1</Words>
  <Application>Microsoft Macintosh PowerPoint</Application>
  <PresentationFormat>Letter Paper (8.5x11 in)</PresentationFormat>
  <Paragraphs>19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lby Montague</dc:creator>
  <cp:lastModifiedBy>Shelby Montague</cp:lastModifiedBy>
  <cp:revision>5</cp:revision>
  <dcterms:created xsi:type="dcterms:W3CDTF">2016-09-29T23:23:19Z</dcterms:created>
  <dcterms:modified xsi:type="dcterms:W3CDTF">2016-09-29T23:25:02Z</dcterms:modified>
</cp:coreProperties>
</file>